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8" d="100"/>
          <a:sy n="78" d="100"/>
        </p:scale>
        <p:origin x="15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461ADA6-7A84-C2FA-9623-6676D37FEBD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2F637BE1-7171-15CB-43D3-5603C4FEAC1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4E73A98-EB7B-79C1-926A-746722E4AA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40E90BB-4151-A219-FED4-83CCC1C34C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5C8501F-E5CA-A0A1-E157-CA6A50C289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454311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FE75267-B452-C43F-FA99-F32A39ACC3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6A7D6C16-2A88-2C62-FD62-45A14067DC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B5C9E5A-269C-18BD-B926-08A75D7EAF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02E385B-53D7-63A3-70F4-A68B33018C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26A84D8-6C0F-93BB-D48A-16598F26AC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01806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4D60C14D-623F-D62C-7619-79DD1313465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310A717-1A53-3DC1-8C24-CB21AB3668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C006B68-F6A8-A48F-B1C9-1511FF7D76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FAD36C5-15E2-412D-66E5-E9562A644A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6339B34-05A6-C98F-22A6-A2C3C7B080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382804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92C78E1-93DE-F610-1280-1FA7F51E6A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6A916F4-BDC6-FC0D-306D-9572E4D9BAF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23227B9-CF43-E0A5-5904-AD4D1F7AEE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C940CAC-72D9-F0BA-9F8B-BA51B66468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22DF34C-FFAA-B2A2-979B-17DB31E35B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70231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086BB58-9438-826B-E4CB-8F7DDFFBD8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C61DAEE-7D43-6AB0-EFCA-F191E30BE4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B990CE8-4C5B-4B1F-0163-3A443EB173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9A456BE-FE0C-D902-87BE-A0E8D02E0D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F884850-6927-3691-18C5-9AE3810907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113682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187A19D-053A-EE20-A2E4-874D5BBF04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B309215F-B877-A28C-5D5B-FD70DADD357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3250455E-C787-63B2-238D-36011421044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94D83756-667B-A014-EE54-5307A59739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F34C8455-81D8-9408-7E7A-718E10F4DF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2AE205BB-FFE2-B0E1-018F-17187EECDB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15804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86353DD-915B-93E7-8902-54867F54A2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0D8E24AC-FFD6-B7AA-F7E1-322681A834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76BDCBC2-9D59-AE18-2D54-305A62EB048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456DE9FF-44CD-EAC4-D772-04090D4F83C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CED705AB-62EB-54EF-FCE4-77C36C17A90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8520EE8D-62BE-574F-71B5-E68FC30DAF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4ED567A8-9C76-20E3-1037-8EE0E769C4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7EFD744B-1173-799F-0C2F-19936CF967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38935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36F7AD3-686E-EC93-B60A-529510620B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1BE97776-8E3B-FA36-2928-CB09C188E9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73C4F5DA-7CFA-76FD-F3C6-2913AF1EFC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D725C1C7-49D5-DD76-321B-680E82DEE9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519025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944AD307-B8C8-99E1-01C0-660F7AD081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87AE6A4B-08A8-91BF-9038-0BD27ACE44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5AEA2AED-661F-D7FC-59A3-35DBAD1D1B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00879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5B2DEDC-1761-C920-46C5-D50351CDAA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88BF9A6B-2AAC-AE62-E60A-756EF0C05FD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27ABD7B1-3C68-51A5-E48A-D0AC39EBC8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9F8D5E29-563A-450C-53DD-2A6198BD5C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415B05CC-639E-8949-21CB-1B56C29A46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93E8010-90DF-B169-F8AD-15E8BF6AB5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078222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A19A17B-F00B-5940-6BA4-63B79D98B2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8C657E23-353E-B19F-701F-558B8EB11B2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3A6C8984-B9C8-BC01-4CB2-ED63FB6E2F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ADE79333-78F1-BB21-CD09-570C895352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108DD30-7EC1-E568-4CA3-28D541ADCB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493B515-DD2B-E142-2930-D48D654045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326094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6FC24857-B5D8-7B95-1829-5B35C7B87E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A0614A6C-D42F-CF41-886A-B082CEDA7B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ED8C50D-00F3-DC67-CE09-CF76E9B25C6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4E40132-97E3-AD9A-D10E-C380622B283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1CB06EA-AC67-B144-D3F7-019290FB90B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87651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BDA94CE-1E88-DEDC-4051-1B19F7FB8CB2}"/>
              </a:ext>
            </a:extLst>
          </p:cNvPr>
          <p:cNvSpPr txBox="1"/>
          <p:nvPr/>
        </p:nvSpPr>
        <p:spPr>
          <a:xfrm>
            <a:off x="0" y="107758"/>
            <a:ext cx="12192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Supplementary Video 6. Time-lapse live-cell imaging confocal microscopy of PMR in </a:t>
            </a:r>
            <a:r>
              <a:rPr lang="en-US" altLang="ko-KR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HT-29-shSIGLEC12 stable cell line </a:t>
            </a:r>
            <a:r>
              <a:rPr lang="en-US" altLang="ko-KR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during necroptosis (</a:t>
            </a:r>
            <a:r>
              <a:rPr lang="en-US" altLang="ko-KR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high magnification of the brightfield channel)</a:t>
            </a:r>
            <a:r>
              <a:rPr lang="en-US" altLang="ko-KR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.</a:t>
            </a:r>
            <a:endParaRPr lang="ko-KR" alt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53016EB-CCC8-2DAA-CD3F-17CF0D71447F}"/>
              </a:ext>
            </a:extLst>
          </p:cNvPr>
          <p:cNvSpPr txBox="1"/>
          <p:nvPr/>
        </p:nvSpPr>
        <p:spPr>
          <a:xfrm>
            <a:off x="9309838" y="6333900"/>
            <a:ext cx="27145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h et al., Supplementary Video 6.</a:t>
            </a:r>
          </a:p>
        </p:txBody>
      </p:sp>
      <p:pic>
        <p:nvPicPr>
          <p:cNvPr id="4" name="HN-S12-40X.nd2 - HN-S12-40X.nd2 (series 21)- shS12-2 TSE">
            <a:hlinkClick r:id="" action="ppaction://media"/>
            <a:extLst>
              <a:ext uri="{FF2B5EF4-FFF2-40B4-BE49-F238E27FC236}">
                <a16:creationId xmlns:a16="http://schemas.microsoft.com/office/drawing/2014/main" id="{39FA8B30-FDCA-EFE9-64AB-6C414509020F}"/>
              </a:ext>
            </a:extLst>
          </p:cNvPr>
          <p:cNvPicPr preferRelativeResize="0">
            <a:picLocks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810000" y="1143000"/>
            <a:ext cx="4572000" cy="457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9908086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6333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34</Words>
  <Application>Microsoft Office PowerPoint</Application>
  <PresentationFormat>와이드스크린</PresentationFormat>
  <Paragraphs>2</Paragraphs>
  <Slides>1</Slides>
  <Notes>0</Notes>
  <HiddenSlides>0</HiddenSlides>
  <MMClips>1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YUNJIN NOH</dc:creator>
  <cp:lastModifiedBy>HYUNJIN NOH</cp:lastModifiedBy>
  <cp:revision>3</cp:revision>
  <dcterms:created xsi:type="dcterms:W3CDTF">2024-12-12T08:27:33Z</dcterms:created>
  <dcterms:modified xsi:type="dcterms:W3CDTF">2024-12-12T22:22:32Z</dcterms:modified>
</cp:coreProperties>
</file>